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E428FDC-4332-4379-A9C7-06688DBC783D}" v="1" dt="2025-07-28T20:03:33.24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ng, Yuyang" userId="624bfbdb-7781-46f6-b49b-a5fb0dad298f" providerId="ADAL" clId="{CE428FDC-4332-4379-A9C7-06688DBC783D}"/>
    <pc:docChg chg="modSld">
      <pc:chgData name="Tang, Yuyang" userId="624bfbdb-7781-46f6-b49b-a5fb0dad298f" providerId="ADAL" clId="{CE428FDC-4332-4379-A9C7-06688DBC783D}" dt="2025-07-28T20:04:41.976" v="5" actId="20577"/>
      <pc:docMkLst>
        <pc:docMk/>
      </pc:docMkLst>
      <pc:sldChg chg="modSp mod">
        <pc:chgData name="Tang, Yuyang" userId="624bfbdb-7781-46f6-b49b-a5fb0dad298f" providerId="ADAL" clId="{CE428FDC-4332-4379-A9C7-06688DBC783D}" dt="2025-07-28T20:04:41.976" v="5" actId="20577"/>
        <pc:sldMkLst>
          <pc:docMk/>
          <pc:sldMk cId="66985153" sldId="274"/>
        </pc:sldMkLst>
        <pc:spChg chg="mod">
          <ac:chgData name="Tang, Yuyang" userId="624bfbdb-7781-46f6-b49b-a5fb0dad298f" providerId="ADAL" clId="{CE428FDC-4332-4379-A9C7-06688DBC783D}" dt="2025-07-28T20:04:41.976" v="5" actId="20577"/>
          <ac:spMkLst>
            <pc:docMk/>
            <pc:sldMk cId="66985153" sldId="274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8315C-F2A4-8023-2A51-FAC417D864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CC22CC-446C-0720-2317-0AA92C1576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9347F0-644B-DA62-365F-C0FC570CBD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2C3C79-64BE-8D6B-5F18-063C684D4F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6066FE-0920-9BC0-4DFF-88D2671D8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830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C02AA-6ED4-D176-6717-4A69EAB81C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4AFA73-B1A9-F7ED-36C5-3824A5EB31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DF98B-6DBA-B7F4-DB0B-3662E4E43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27F38E-9C1A-E681-4180-2306EDD83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D36D8F-399A-07E2-ED69-47B73D849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78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D38C2CF-99C6-64E9-366A-5B3195B767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3215E4-D682-BE3F-A801-39DE3C641A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0013C1-0FEF-9F30-B46C-D1B18BEA2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27C42E-96BC-DDC5-7AC1-5D1D5DB27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381EE5-33A3-5B8F-CD24-52DA57F75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789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F396D6-B5E2-FD50-4F82-A045214C43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EDA29C-090A-E660-4EC6-0DCAFE762C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63314F-8B22-B3BB-B62B-30996D00E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2F147D-530D-3336-8F45-779EA6F42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EF6D32-15A4-C59D-2E27-72BE6D6B0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479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A1D53A-05DF-4207-E135-F13A68E954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AF7007-D76B-3E67-7D70-4A6DED44B1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5D1C93-2037-CE8F-47D5-8F1003B4A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8E2680-D1EE-E61F-865B-235320713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0FDFF-1279-2E5A-BBE6-F220F1FE91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153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50AA11-2940-9B27-CAD8-3A0C0FF93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8C78C-3DCE-9DC6-AF5C-EF690E1929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FD22AC-B398-36F0-CC83-1C61E6D9A9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97DC57-4390-1704-34D8-51B1276D9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9468FB-9EE9-E7F4-58B7-D01869A57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4C7B0C-CAE8-FE41-D437-7177202C4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8781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B7E65-B65F-5A8E-14B3-513221768C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67D4E7-7C26-4CAB-F009-3387F34764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5EA6AA-8E63-A054-5347-7EBE2E8B44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5DE626B-0E09-4D9A-B6FC-5ADEAD141F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C5671-D35A-3FC9-C339-21A897B3EA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DD8DBA-4148-F493-9B92-9B1E645EA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D8EE483-D914-26B0-741B-2DF46BC20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34E86BC-68E4-DEBB-24DA-2550F273E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629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717F72-7C6C-37CA-A9E3-B28523EA3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779B04-F3F2-C781-E14D-58817505F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553EAB7-91DD-3D9E-EC04-F9A4D5369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E0F5B4-A4D4-D74F-09CC-839C81889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06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1673282-79BF-6E15-F201-2F8A64BC7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7FD946-E3E7-6217-7418-BBDA66B83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F0E8FEE-18C0-7439-E52C-137125C87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648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66689-A6EB-F1AD-912C-B386A1421A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C0721D-F4CC-8725-3409-47076F4CF6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778451-3AC4-1893-6AB7-50CA57AFFC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0B4A80-D268-2AF5-7CFD-D499FD948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F34BFD-E128-2404-33AF-A93248BE6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7ED130-2B70-A6D8-2BA5-BEE9ED0AD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191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771070-1A19-1A06-BCB6-533DBA6A86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3F8460-7C1B-6D7A-8AF5-CECA88F29F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278B93-D801-3344-ADA3-67F680B937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A088CC-954C-5330-42ED-F3E238105B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71789B-69EE-D5AF-3434-44461C3E9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7C2F47-E088-13C0-BD07-B996AE14CF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123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BBD6997-BE46-1571-534F-006271EE9D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E46C31-F5DC-5751-5E3C-67E866ABE5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6979C3-9473-1151-24E3-1A5A26719F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E2F005-32BA-49DC-8B3E-DD516D2925AE}" type="datetimeFigureOut">
              <a:rPr lang="en-US" smtClean="0"/>
              <a:t>7/2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AFA6A2-6144-0125-F979-D078E7C0A7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C0B519-CC38-2485-5618-A43DA675CA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C3B468-4A99-4BEC-9810-3CB234620C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0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2268821" y="348243"/>
          <a:ext cx="5052798" cy="6020401"/>
        </p:xfrm>
        <a:graphic>
          <a:graphicData uri="http://schemas.openxmlformats.org/drawingml/2006/table">
            <a:tbl>
              <a:tblPr/>
              <a:tblGrid>
                <a:gridCol w="842133">
                  <a:extLst>
                    <a:ext uri="{9D8B030D-6E8A-4147-A177-3AD203B41FA5}">
                      <a16:colId xmlns:a16="http://schemas.microsoft.com/office/drawing/2014/main" val="3349032378"/>
                    </a:ext>
                  </a:extLst>
                </a:gridCol>
                <a:gridCol w="842133">
                  <a:extLst>
                    <a:ext uri="{9D8B030D-6E8A-4147-A177-3AD203B41FA5}">
                      <a16:colId xmlns:a16="http://schemas.microsoft.com/office/drawing/2014/main" val="1729026004"/>
                    </a:ext>
                  </a:extLst>
                </a:gridCol>
                <a:gridCol w="842133">
                  <a:extLst>
                    <a:ext uri="{9D8B030D-6E8A-4147-A177-3AD203B41FA5}">
                      <a16:colId xmlns:a16="http://schemas.microsoft.com/office/drawing/2014/main" val="4265024535"/>
                    </a:ext>
                  </a:extLst>
                </a:gridCol>
                <a:gridCol w="842133">
                  <a:extLst>
                    <a:ext uri="{9D8B030D-6E8A-4147-A177-3AD203B41FA5}">
                      <a16:colId xmlns:a16="http://schemas.microsoft.com/office/drawing/2014/main" val="1027008565"/>
                    </a:ext>
                  </a:extLst>
                </a:gridCol>
                <a:gridCol w="842133">
                  <a:extLst>
                    <a:ext uri="{9D8B030D-6E8A-4147-A177-3AD203B41FA5}">
                      <a16:colId xmlns:a16="http://schemas.microsoft.com/office/drawing/2014/main" val="1313571920"/>
                    </a:ext>
                  </a:extLst>
                </a:gridCol>
                <a:gridCol w="842133">
                  <a:extLst>
                    <a:ext uri="{9D8B030D-6E8A-4147-A177-3AD203B41FA5}">
                      <a16:colId xmlns:a16="http://schemas.microsoft.com/office/drawing/2014/main" val="1696417474"/>
                    </a:ext>
                  </a:extLst>
                </a:gridCol>
              </a:tblGrid>
              <a:tr h="207336"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M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WM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7224870"/>
                  </a:ext>
                </a:extLst>
              </a:tr>
              <a:tr h="20614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name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 1&amp;2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 2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 3&amp;4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t</a:t>
                      </a:r>
                      <a:r>
                        <a:rPr lang="en-US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33406"/>
                  </a:ext>
                </a:extLst>
              </a:tr>
              <a:tr h="411985"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  <a:r>
                        <a:rPr lang="en-US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</a:t>
                      </a:r>
                      <a:r>
                        <a:rPr lang="en-US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I</a:t>
                      </a:r>
                      <a:r>
                        <a:rPr lang="en-US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D</a:t>
                      </a:r>
                      <a:r>
                        <a:rPr lang="en-US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contro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ND/ANI</a:t>
                      </a:r>
                      <a:r>
                        <a:rPr lang="en-US" sz="12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s 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6399" marR="6399" marT="639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972620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OT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6363513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OC2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5148360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9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2324801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BPB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907220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X34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5260690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NM2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51175285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634598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TM4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2752272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A2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5835835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HM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5885042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J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7820768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K6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0274095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NDC1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2179902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PCAT2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4989330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RP2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0522134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CH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1340947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F4GD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7554718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P3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6028448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1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BP4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1651389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LDA3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3781735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16A1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1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029249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LC4A3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9422292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ST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3070409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4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EAL7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8506284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F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3948493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SPAN8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6171958"/>
                  </a:ext>
                </a:extLst>
              </a:tr>
              <a:tr h="1584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2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QCRQ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wn 0.5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D7EE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8" marR="7018" marT="70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8424520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2147762" y="71244"/>
            <a:ext cx="531181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8 Table. </a:t>
            </a:r>
            <a:r>
              <a:rPr lang="en-US" sz="1200" b="1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own regulation of 27 proteins in HAND brain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4230350-3D6A-190D-AB09-BCE80A954227}"/>
              </a:ext>
            </a:extLst>
          </p:cNvPr>
          <p:cNvSpPr txBox="1"/>
          <p:nvPr/>
        </p:nvSpPr>
        <p:spPr>
          <a:xfrm>
            <a:off x="2147762" y="6366765"/>
            <a:ext cx="4666786" cy="27699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solidFill>
                  <a:srgbClr val="1C1D1E"/>
                </a:solidFill>
                <a:latin typeface="Arial"/>
                <a:cs typeface="Arial"/>
              </a:rPr>
              <a:t>Abbreviations: Con, control; GM, Grey Matter; WM, White matter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A9918B-E485-7A47-BEFF-937DD804AD82}"/>
              </a:ext>
            </a:extLst>
          </p:cNvPr>
          <p:cNvSpPr txBox="1"/>
          <p:nvPr/>
        </p:nvSpPr>
        <p:spPr>
          <a:xfrm flipH="1">
            <a:off x="2147762" y="6581001"/>
            <a:ext cx="3457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te: The data represent Log2 ratio to control.</a:t>
            </a:r>
          </a:p>
        </p:txBody>
      </p:sp>
    </p:spTree>
    <p:extLst>
      <p:ext uri="{BB962C8B-B14F-4D97-AF65-F5344CB8AC3E}">
        <p14:creationId xmlns:p14="http://schemas.microsoft.com/office/powerpoint/2010/main" val="669851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4</Words>
  <Application>Microsoft Office PowerPoint</Application>
  <PresentationFormat>Widescreen</PresentationFormat>
  <Paragraphs>1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ng, Yuyang</dc:creator>
  <cp:lastModifiedBy>Tang, Yuyang</cp:lastModifiedBy>
  <cp:revision>1</cp:revision>
  <dcterms:created xsi:type="dcterms:W3CDTF">2025-07-28T20:03:01Z</dcterms:created>
  <dcterms:modified xsi:type="dcterms:W3CDTF">2025-07-28T20:04:43Z</dcterms:modified>
</cp:coreProperties>
</file>